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7864475" cy="87788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FBFBF"/>
    <a:srgbClr val="D9D9D9"/>
    <a:srgbClr val="CC00CC"/>
    <a:srgbClr val="00CC00"/>
    <a:srgbClr val="7F7F7F"/>
    <a:srgbClr val="A6A6A6"/>
    <a:srgbClr val="FF9966"/>
    <a:srgbClr val="FFFF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496" y="-12"/>
      </p:cViewPr>
      <p:guideLst>
        <p:guide orient="horz" pos="1517"/>
        <p:guide pos="4493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ocuments\Project%20at%20UIUC\QingLi_2011-2012\Arabidopsis%20haploid\1manuscript\20130529%20version\New%20figures%20about%20methylation%20and%20XWD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ocuments\Project%20at%20UIUC\QingLi_2011-2012\Arabidopsis%20haploid\1manuscript\20130529%20version\New%20figures%20about%20methylation%20and%20XWD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ocuments\Project%20at%20UIUC\QingLi_2011-2012\Arabidopsis%20haploid\1manuscript\20130529%20version\New%20figures%20about%20methylation%20and%20XWD%20da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Qing%20Li\Documents\Project%20at%20UIUC\QingLi_2011-2012\Arabidopsis%20haploid\1manuscript\20130529%20version\New%20figures%20about%20methylation%20and%20XWD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27911145253191"/>
          <c:y val="6.1624649859944022E-2"/>
          <c:w val="0.39463922272873775"/>
          <c:h val="0.83172721056927224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xwd!$B$40</c:f>
              <c:strCache>
                <c:ptCount val="1"/>
                <c:pt idx="0">
                  <c:v>CG and C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33:$D$33</c:f>
              <c:strCache>
                <c:ptCount val="2"/>
                <c:pt idx="0">
                  <c:v>ss sRNA ≥ 90%</c:v>
                </c:pt>
                <c:pt idx="1">
                  <c:v>other</c:v>
                </c:pt>
              </c:strCache>
            </c:strRef>
          </c:cat>
          <c:val>
            <c:numRef>
              <c:f>xwd!$C$40:$D$40</c:f>
              <c:numCache>
                <c:formatCode>0.0</c:formatCode>
                <c:ptCount val="2"/>
                <c:pt idx="0">
                  <c:v>1.1278195488721798</c:v>
                </c:pt>
                <c:pt idx="1">
                  <c:v>16.141732283464489</c:v>
                </c:pt>
              </c:numCache>
            </c:numRef>
          </c:val>
        </c:ser>
        <c:ser>
          <c:idx val="1"/>
          <c:order val="1"/>
          <c:tx>
            <c:strRef>
              <c:f>xwd!$B$41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33:$D$33</c:f>
              <c:strCache>
                <c:ptCount val="2"/>
                <c:pt idx="0">
                  <c:v>ss sRNA ≥ 90%</c:v>
                </c:pt>
                <c:pt idx="1">
                  <c:v>other</c:v>
                </c:pt>
              </c:strCache>
            </c:strRef>
          </c:cat>
          <c:val>
            <c:numRef>
              <c:f>xwd!$C$41:$D$41</c:f>
              <c:numCache>
                <c:formatCode>0.0</c:formatCode>
                <c:ptCount val="2"/>
                <c:pt idx="0">
                  <c:v>8.2706766917293226</c:v>
                </c:pt>
                <c:pt idx="1">
                  <c:v>23.228346456692886</c:v>
                </c:pt>
              </c:numCache>
            </c:numRef>
          </c:val>
        </c:ser>
        <c:ser>
          <c:idx val="2"/>
          <c:order val="2"/>
          <c:tx>
            <c:strRef>
              <c:f>xwd!$B$42</c:f>
              <c:strCache>
                <c:ptCount val="1"/>
                <c:pt idx="0">
                  <c:v>CG</c:v>
                </c:pt>
              </c:strCache>
            </c:strRef>
          </c:tx>
          <c:spPr>
            <a:solidFill>
              <a:srgbClr val="D9D9D9"/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33:$D$33</c:f>
              <c:strCache>
                <c:ptCount val="2"/>
                <c:pt idx="0">
                  <c:v>ss sRNA ≥ 90%</c:v>
                </c:pt>
                <c:pt idx="1">
                  <c:v>other</c:v>
                </c:pt>
              </c:strCache>
            </c:strRef>
          </c:cat>
          <c:val>
            <c:numRef>
              <c:f>xwd!$C$42:$D$42</c:f>
              <c:numCache>
                <c:formatCode>0.0</c:formatCode>
                <c:ptCount val="2"/>
                <c:pt idx="0">
                  <c:v>57.894736842105488</c:v>
                </c:pt>
                <c:pt idx="1">
                  <c:v>35.039370078740156</c:v>
                </c:pt>
              </c:numCache>
            </c:numRef>
          </c:val>
        </c:ser>
        <c:ser>
          <c:idx val="3"/>
          <c:order val="3"/>
          <c:tx>
            <c:strRef>
              <c:f>xwd!$B$43</c:f>
              <c:strCache>
                <c:ptCount val="1"/>
                <c:pt idx="0">
                  <c:v>No methylation</c:v>
                </c:pt>
              </c:strCache>
            </c:strRef>
          </c:tx>
          <c:spPr>
            <a:noFill/>
            <a:ln>
              <a:solidFill>
                <a:prstClr val="black"/>
              </a:solidFill>
            </a:ln>
          </c:spPr>
          <c:invertIfNegative val="0"/>
          <c:cat>
            <c:strRef>
              <c:f>xwd!$C$33:$D$33</c:f>
              <c:strCache>
                <c:ptCount val="2"/>
                <c:pt idx="0">
                  <c:v>ss sRNA ≥ 90%</c:v>
                </c:pt>
                <c:pt idx="1">
                  <c:v>other</c:v>
                </c:pt>
              </c:strCache>
            </c:strRef>
          </c:cat>
          <c:val>
            <c:numRef>
              <c:f>xwd!$C$43:$D$43</c:f>
              <c:numCache>
                <c:formatCode>0.0</c:formatCode>
                <c:ptCount val="2"/>
                <c:pt idx="0">
                  <c:v>32.706766917293194</c:v>
                </c:pt>
                <c:pt idx="1">
                  <c:v>25.5905511811023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overlap val="100"/>
        <c:axId val="33759232"/>
        <c:axId val="33760768"/>
      </c:barChart>
      <c:catAx>
        <c:axId val="33759232"/>
        <c:scaling>
          <c:orientation val="minMax"/>
        </c:scaling>
        <c:delete val="0"/>
        <c:axPos val="b"/>
        <c:majorTickMark val="out"/>
        <c:minorTickMark val="none"/>
        <c:tickLblPos val="none"/>
        <c:crossAx val="33760768"/>
        <c:crosses val="autoZero"/>
        <c:auto val="1"/>
        <c:lblAlgn val="ctr"/>
        <c:lblOffset val="100"/>
        <c:noMultiLvlLbl val="0"/>
      </c:catAx>
      <c:valAx>
        <c:axId val="3376076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crossAx val="33759232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xwd!$L$7</c:f>
              <c:strCache>
                <c:ptCount val="1"/>
              </c:strCache>
            </c:strRef>
          </c:tx>
          <c:spPr>
            <a:noFill/>
            <a:ln>
              <a:solidFill>
                <a:prstClr val="black"/>
              </a:solidFill>
            </a:ln>
          </c:spPr>
          <c:dPt>
            <c:idx val="1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prstClr val="black"/>
                </a:solidFill>
              </a:ln>
            </c:spPr>
          </c:dPt>
          <c:val>
            <c:numRef>
              <c:f>xwd!$N$8:$N$9</c:f>
              <c:numCache>
                <c:formatCode>General</c:formatCode>
                <c:ptCount val="2"/>
                <c:pt idx="0">
                  <c:v>89.534883720930267</c:v>
                </c:pt>
                <c:pt idx="1">
                  <c:v>10.4651162790698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pieChart>
        <c:varyColors val="1"/>
        <c:ser>
          <c:idx val="0"/>
          <c:order val="0"/>
          <c:tx>
            <c:strRef>
              <c:f>xwd!$L$7</c:f>
              <c:strCache>
                <c:ptCount val="1"/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dPt>
            <c:idx val="1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</c:spPr>
          </c:dPt>
          <c:val>
            <c:numRef>
              <c:f>xwd!$O$8:$O$9</c:f>
              <c:numCache>
                <c:formatCode>General</c:formatCode>
                <c:ptCount val="2"/>
                <c:pt idx="0">
                  <c:v>54.511278195488721</c:v>
                </c:pt>
                <c:pt idx="1">
                  <c:v>45.4887218045112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27911145253191"/>
          <c:y val="6.1624649859944022E-2"/>
          <c:w val="0.39463922272873775"/>
          <c:h val="0.8317272105692727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xwd!$B$56</c:f>
              <c:strCache>
                <c:ptCount val="1"/>
                <c:pt idx="0">
                  <c:v>CG and C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49:$E$49</c:f>
              <c:strCache>
                <c:ptCount val="3"/>
                <c:pt idx="0">
                  <c:v>&lt;-0.5</c:v>
                </c:pt>
                <c:pt idx="1">
                  <c:v>-0.5~0.5</c:v>
                </c:pt>
                <c:pt idx="2">
                  <c:v>&gt;0.5</c:v>
                </c:pt>
              </c:strCache>
            </c:strRef>
          </c:cat>
          <c:val>
            <c:numRef>
              <c:f>xwd!$C$56:$E$56</c:f>
              <c:numCache>
                <c:formatCode>0.0</c:formatCode>
                <c:ptCount val="3"/>
                <c:pt idx="0">
                  <c:v>17.142857142857231</c:v>
                </c:pt>
                <c:pt idx="1">
                  <c:v>3.6363636363636327</c:v>
                </c:pt>
                <c:pt idx="2">
                  <c:v>3.9215686274509798</c:v>
                </c:pt>
              </c:numCache>
            </c:numRef>
          </c:val>
        </c:ser>
        <c:ser>
          <c:idx val="1"/>
          <c:order val="1"/>
          <c:tx>
            <c:strRef>
              <c:f>xwd!$B$57</c:f>
              <c:strCache>
                <c:ptCount val="1"/>
                <c:pt idx="0">
                  <c:v>C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49:$E$49</c:f>
              <c:strCache>
                <c:ptCount val="3"/>
                <c:pt idx="0">
                  <c:v>&lt;-0.5</c:v>
                </c:pt>
                <c:pt idx="1">
                  <c:v>-0.5~0.5</c:v>
                </c:pt>
                <c:pt idx="2">
                  <c:v>&gt;0.5</c:v>
                </c:pt>
              </c:strCache>
            </c:strRef>
          </c:cat>
          <c:val>
            <c:numRef>
              <c:f>xwd!$C$57:$E$57</c:f>
              <c:numCache>
                <c:formatCode>0.0</c:formatCode>
                <c:ptCount val="3"/>
                <c:pt idx="0">
                  <c:v>31.428571428571427</c:v>
                </c:pt>
                <c:pt idx="1">
                  <c:v>41.818181818181863</c:v>
                </c:pt>
                <c:pt idx="2">
                  <c:v>29.411764705882351</c:v>
                </c:pt>
              </c:numCache>
            </c:numRef>
          </c:val>
        </c:ser>
        <c:ser>
          <c:idx val="2"/>
          <c:order val="2"/>
          <c:tx>
            <c:strRef>
              <c:f>xwd!$B$58</c:f>
              <c:strCache>
                <c:ptCount val="1"/>
                <c:pt idx="0">
                  <c:v>CG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prstClr val="black"/>
              </a:solidFill>
            </a:ln>
          </c:spPr>
          <c:invertIfNegative val="0"/>
          <c:cat>
            <c:strRef>
              <c:f>xwd!$C$49:$E$49</c:f>
              <c:strCache>
                <c:ptCount val="3"/>
                <c:pt idx="0">
                  <c:v>&lt;-0.5</c:v>
                </c:pt>
                <c:pt idx="1">
                  <c:v>-0.5~0.5</c:v>
                </c:pt>
                <c:pt idx="2">
                  <c:v>&gt;0.5</c:v>
                </c:pt>
              </c:strCache>
            </c:strRef>
          </c:cat>
          <c:val>
            <c:numRef>
              <c:f>xwd!$C$58:$E$58</c:f>
              <c:numCache>
                <c:formatCode>0.0</c:formatCode>
                <c:ptCount val="3"/>
                <c:pt idx="0">
                  <c:v>22.857142857142829</c:v>
                </c:pt>
                <c:pt idx="1">
                  <c:v>25.454545454545453</c:v>
                </c:pt>
                <c:pt idx="2">
                  <c:v>29.411764705882351</c:v>
                </c:pt>
              </c:numCache>
            </c:numRef>
          </c:val>
        </c:ser>
        <c:ser>
          <c:idx val="3"/>
          <c:order val="3"/>
          <c:tx>
            <c:strRef>
              <c:f>xwd!$B$59</c:f>
              <c:strCache>
                <c:ptCount val="1"/>
                <c:pt idx="0">
                  <c:v>No methylation</c:v>
                </c:pt>
              </c:strCache>
            </c:strRef>
          </c:tx>
          <c:spPr>
            <a:noFill/>
            <a:ln>
              <a:solidFill>
                <a:prstClr val="black"/>
              </a:solidFill>
            </a:ln>
          </c:spPr>
          <c:invertIfNegative val="0"/>
          <c:cat>
            <c:strRef>
              <c:f>xwd!$C$49:$E$49</c:f>
              <c:strCache>
                <c:ptCount val="3"/>
                <c:pt idx="0">
                  <c:v>&lt;-0.5</c:v>
                </c:pt>
                <c:pt idx="1">
                  <c:v>-0.5~0.5</c:v>
                </c:pt>
                <c:pt idx="2">
                  <c:v>&gt;0.5</c:v>
                </c:pt>
              </c:strCache>
            </c:strRef>
          </c:cat>
          <c:val>
            <c:numRef>
              <c:f>xwd!$C$59:$E$59</c:f>
              <c:numCache>
                <c:formatCode>0.0</c:formatCode>
                <c:ptCount val="3"/>
                <c:pt idx="0">
                  <c:v>28.571428571428573</c:v>
                </c:pt>
                <c:pt idx="1">
                  <c:v>29.090909090909086</c:v>
                </c:pt>
                <c:pt idx="2">
                  <c:v>37.254901960784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overlap val="100"/>
        <c:axId val="34320384"/>
        <c:axId val="34321920"/>
      </c:barChart>
      <c:catAx>
        <c:axId val="34320384"/>
        <c:scaling>
          <c:orientation val="minMax"/>
        </c:scaling>
        <c:delete val="0"/>
        <c:axPos val="b"/>
        <c:majorTickMark val="out"/>
        <c:minorTickMark val="none"/>
        <c:tickLblPos val="nextTo"/>
        <c:crossAx val="34321920"/>
        <c:crosses val="autoZero"/>
        <c:auto val="1"/>
        <c:lblAlgn val="ctr"/>
        <c:lblOffset val="100"/>
        <c:noMultiLvlLbl val="0"/>
      </c:catAx>
      <c:valAx>
        <c:axId val="34321920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crossAx val="34320384"/>
        <c:crosses val="autoZero"/>
        <c:crossBetween val="between"/>
        <c:majorUnit val="0.2"/>
      </c:valAx>
    </c:plotArea>
    <c:legend>
      <c:legendPos val="r"/>
      <c:legendEntry>
        <c:idx val="3"/>
        <c:delete val="1"/>
      </c:legendEntry>
      <c:layout>
        <c:manualLayout>
          <c:xMode val="edge"/>
          <c:yMode val="edge"/>
          <c:x val="0.5719879901375966"/>
          <c:y val="0.18083431060479141"/>
          <c:w val="0.39923486836872818"/>
          <c:h val="0.33457365349992585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2C9D4C-51EA-45DB-B9CA-E78420898B6F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92300" y="685800"/>
            <a:ext cx="30734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35B42-A990-4A5C-838A-C4F422C2772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442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9839" y="2727141"/>
            <a:ext cx="6684803" cy="18817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79675" y="4974696"/>
            <a:ext cx="5505133" cy="22434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701747" y="351565"/>
            <a:ext cx="1769507" cy="749049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93224" y="351565"/>
            <a:ext cx="5177446" cy="749049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1243" y="5641241"/>
            <a:ext cx="6684803" cy="174358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1243" y="3720863"/>
            <a:ext cx="6684803" cy="192037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93224" y="2048405"/>
            <a:ext cx="3473476" cy="57936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97775" y="2048405"/>
            <a:ext cx="3473476" cy="579365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3225" y="1965090"/>
            <a:ext cx="3474842" cy="818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225" y="2784046"/>
            <a:ext cx="3474842" cy="50580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95049" y="1965090"/>
            <a:ext cx="3476207" cy="818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95049" y="2784046"/>
            <a:ext cx="3476207" cy="50580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93225" y="349530"/>
            <a:ext cx="2587358" cy="148753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4792" y="349533"/>
            <a:ext cx="4396460" cy="749252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93225" y="1837066"/>
            <a:ext cx="2587358" cy="600499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41495" y="6145216"/>
            <a:ext cx="4718685" cy="72547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41495" y="784411"/>
            <a:ext cx="4718685" cy="52673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41495" y="6870691"/>
            <a:ext cx="4718685" cy="103029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93227" y="351562"/>
            <a:ext cx="7078027" cy="14631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93227" y="2048405"/>
            <a:ext cx="7078027" cy="57936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93224" y="8136717"/>
            <a:ext cx="1835044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87033" y="8136717"/>
            <a:ext cx="2490417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636207" y="8136717"/>
            <a:ext cx="1835044" cy="4673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2.png"/><Relationship Id="rId7" Type="http://schemas.openxmlformats.org/officeDocument/2006/relationships/chart" Target="../charts/chart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5" name="Picture 7"/>
          <p:cNvPicPr>
            <a:picLocks noChangeArrowheads="1"/>
          </p:cNvPicPr>
          <p:nvPr/>
        </p:nvPicPr>
        <p:blipFill>
          <a:blip r:embed="rId2" cstate="print"/>
          <a:srcRect l="28235" t="21365" r="15294" b="26409"/>
          <a:stretch>
            <a:fillRect/>
          </a:stretch>
        </p:blipFill>
        <p:spPr bwMode="auto">
          <a:xfrm>
            <a:off x="1038911" y="2342276"/>
            <a:ext cx="1371600" cy="1737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rrowheads="1"/>
          </p:cNvPicPr>
          <p:nvPr/>
        </p:nvPicPr>
        <p:blipFill>
          <a:blip r:embed="rId3" cstate="print"/>
          <a:srcRect l="29150" t="20513" r="15789" b="27065"/>
          <a:stretch>
            <a:fillRect/>
          </a:stretch>
        </p:blipFill>
        <p:spPr bwMode="auto">
          <a:xfrm>
            <a:off x="3208337" y="333692"/>
            <a:ext cx="1295400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4" cstate="print"/>
          <a:srcRect l="10113" t="7143" r="5614" b="10714"/>
          <a:stretch>
            <a:fillRect/>
          </a:stretch>
        </p:blipFill>
        <p:spPr bwMode="auto">
          <a:xfrm>
            <a:off x="771593" y="381317"/>
            <a:ext cx="1789044" cy="16459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60" name="Chart 59"/>
          <p:cNvGraphicFramePr/>
          <p:nvPr/>
        </p:nvGraphicFramePr>
        <p:xfrm>
          <a:off x="3017837" y="2408237"/>
          <a:ext cx="1645920" cy="1691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-103229" y="943433"/>
            <a:ext cx="15239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log10(</a:t>
            </a:r>
            <a:r>
              <a:rPr lang="en-US" sz="1050" dirty="0" err="1" smtClean="0">
                <a:latin typeface="Arial" pitchFamily="34" charset="0"/>
                <a:cs typeface="Arial" pitchFamily="34" charset="0"/>
              </a:rPr>
              <a:t>sRNA</a:t>
            </a:r>
            <a:r>
              <a:rPr lang="en-US" sz="1050" dirty="0" smtClean="0">
                <a:latin typeface="Arial" pitchFamily="34" charset="0"/>
                <a:cs typeface="Arial" pitchFamily="34" charset="0"/>
              </a:rPr>
              <a:t> level)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17219" y="1984791"/>
            <a:ext cx="131959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log10(mRNA level)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03237" y="46037"/>
            <a:ext cx="3583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84462" y="4603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95470" y="4603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28796" y="1984791"/>
            <a:ext cx="670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I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824204" y="1984791"/>
            <a:ext cx="63350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57322" y="227328"/>
            <a:ext cx="410689" cy="18189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10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8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6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4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2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0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903412" y="384591"/>
            <a:ext cx="670376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I</a:t>
            </a:r>
          </a:p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N = 25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89012" y="384591"/>
            <a:ext cx="660758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</a:t>
            </a:r>
          </a:p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N = 266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1968684" y="1005571"/>
            <a:ext cx="17997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% of sense strand </a:t>
            </a:r>
            <a:r>
              <a:rPr lang="en-US" sz="1050" dirty="0" err="1" smtClean="0">
                <a:latin typeface="Arial" pitchFamily="34" charset="0"/>
                <a:cs typeface="Arial" pitchFamily="34" charset="0"/>
              </a:rPr>
              <a:t>sRNA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427412" y="1222791"/>
            <a:ext cx="7377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P &lt;&lt; 0.01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8" name="Chart 17"/>
          <p:cNvGraphicFramePr/>
          <p:nvPr/>
        </p:nvGraphicFramePr>
        <p:xfrm>
          <a:off x="5561012" y="155991"/>
          <a:ext cx="1600200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Chart 18"/>
          <p:cNvGraphicFramePr/>
          <p:nvPr/>
        </p:nvGraphicFramePr>
        <p:xfrm>
          <a:off x="4446587" y="155991"/>
          <a:ext cx="1600200" cy="1463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" name="TextBox 19"/>
          <p:cNvSpPr txBox="1"/>
          <p:nvPr/>
        </p:nvSpPr>
        <p:spPr>
          <a:xfrm>
            <a:off x="6033636" y="384591"/>
            <a:ext cx="670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I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875212" y="384591"/>
            <a:ext cx="63350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Group I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646612" y="917991"/>
            <a:ext cx="6597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TE+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180012" y="917991"/>
            <a:ext cx="6597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TE-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684837" y="579437"/>
            <a:ext cx="6597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TE+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170612" y="1070391"/>
            <a:ext cx="65974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TE-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03237" y="2154575"/>
            <a:ext cx="3583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773077" y="215457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E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flipH="1">
            <a:off x="4389437" y="2179637"/>
            <a:ext cx="267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F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694897" y="2247026"/>
            <a:ext cx="410689" cy="18189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10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8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6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4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20</a:t>
            </a:r>
          </a:p>
          <a:p>
            <a:pPr algn="r">
              <a:lnSpc>
                <a:spcPts val="2300"/>
              </a:lnSpc>
            </a:pPr>
            <a:r>
              <a:rPr lang="en-US" sz="1050" dirty="0" smtClean="0">
                <a:latin typeface="Arial" pitchFamily="34" charset="0"/>
                <a:cs typeface="Arial" pitchFamily="34" charset="0"/>
              </a:rPr>
              <a:t>0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-193491" y="3125181"/>
            <a:ext cx="179977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% of sense strand </a:t>
            </a:r>
            <a:r>
              <a:rPr lang="en-US" sz="1050" dirty="0" err="1" smtClean="0">
                <a:latin typeface="Arial" pitchFamily="34" charset="0"/>
                <a:cs typeface="Arial" pitchFamily="34" charset="0"/>
              </a:rPr>
              <a:t>sRNA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087152" y="4047251"/>
            <a:ext cx="5325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&lt; -0.5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486586" y="4047251"/>
            <a:ext cx="52372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-0.5 to 0.5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953464" y="4047251"/>
            <a:ext cx="5237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&gt; 0.5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334311" y="423703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d/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61" name="Chart 60"/>
          <p:cNvGraphicFramePr/>
          <p:nvPr/>
        </p:nvGraphicFramePr>
        <p:xfrm>
          <a:off x="4694237" y="2332037"/>
          <a:ext cx="2514600" cy="20116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64" name="Straight Arrow Connector 63"/>
          <p:cNvCxnSpPr/>
          <p:nvPr/>
        </p:nvCxnSpPr>
        <p:spPr>
          <a:xfrm>
            <a:off x="1084631" y="4465637"/>
            <a:ext cx="1371600" cy="0"/>
          </a:xfrm>
          <a:prstGeom prst="straightConnector1">
            <a:avLst/>
          </a:prstGeom>
          <a:ln>
            <a:solidFill>
              <a:schemeClr val="tx1">
                <a:alpha val="99000"/>
              </a:schemeClr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199293" y="4440321"/>
            <a:ext cx="121860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>
                <a:latin typeface="Arial" pitchFamily="34" charset="0"/>
                <a:cs typeface="Arial" pitchFamily="34" charset="0"/>
              </a:rPr>
              <a:t>LP       MP      HP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5837237" y="4237037"/>
            <a:ext cx="5924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itchFamily="34" charset="0"/>
                <a:cs typeface="Arial" pitchFamily="34" charset="0"/>
              </a:rPr>
              <a:t>d/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341687" y="3906921"/>
            <a:ext cx="5429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 pitchFamily="34" charset="0"/>
                <a:cs typeface="Arial" pitchFamily="34" charset="0"/>
              </a:rPr>
              <a:t>Sense &gt; 90%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3722688" y="3906921"/>
            <a:ext cx="533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smtClean="0">
                <a:latin typeface="Arial" pitchFamily="34" charset="0"/>
                <a:cs typeface="Arial" pitchFamily="34" charset="0"/>
              </a:rPr>
              <a:t>Sense &lt; 90%</a:t>
            </a:r>
          </a:p>
        </p:txBody>
      </p:sp>
      <p:sp>
        <p:nvSpPr>
          <p:cNvPr id="68" name="TextBox 67"/>
          <p:cNvSpPr txBox="1"/>
          <p:nvPr/>
        </p:nvSpPr>
        <p:spPr>
          <a:xfrm rot="16200000">
            <a:off x="2292535" y="2990667"/>
            <a:ext cx="12663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% of gene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4010292" y="2990667"/>
            <a:ext cx="12663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 smtClean="0">
                <a:latin typeface="Arial" pitchFamily="34" charset="0"/>
                <a:cs typeface="Arial" pitchFamily="34" charset="0"/>
              </a:rPr>
              <a:t>% of gene</a:t>
            </a:r>
            <a:endParaRPr lang="en-US" sz="105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7</TotalTime>
  <Words>89</Words>
  <Application>Microsoft Office PowerPoint</Application>
  <PresentationFormat>Custom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Qing Li</dc:creator>
  <cp:lastModifiedBy>Qing Li</cp:lastModifiedBy>
  <cp:revision>359</cp:revision>
  <dcterms:created xsi:type="dcterms:W3CDTF">2006-08-16T00:00:00Z</dcterms:created>
  <dcterms:modified xsi:type="dcterms:W3CDTF">2015-06-03T15:33:52Z</dcterms:modified>
</cp:coreProperties>
</file>